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8B65BE-A84B-8A6E-90FB-BB5BAF1541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308446-F6D6-331B-1009-0D851BCDF4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A95A4A-C3CC-2AB5-47EB-BD9E24057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446660-7C71-50F9-B1B1-FF660B59A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393CE1-3E95-00F2-97B4-92391E22B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291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B9215-DA58-7034-19FE-EAA43CD76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2BC6BD-4D05-5CFB-041A-FDA37493FE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C6C70C-CFEA-4491-0FC4-19F7FDB0E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536F91-5A35-62E3-4CDC-46982AFA0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DA2657-6BC3-740C-0E8A-A1DE8EC4C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293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3E01C6-F6D9-29F1-B532-9AA664A539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53163C-E4E4-59D3-A340-F2EABDF8D0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5EEDE-B850-5EA4-B4C4-4F6861829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2F2C4C-CF76-3003-BC92-7EB945A13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7999D1-7087-07B8-89C9-9AF77E4A1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873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C849A4-F11E-DE59-910B-BBB33F4852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6667D3-78B7-BDF5-1BC9-976517328C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8422D1-84FF-D05B-B26E-0EF2D0A20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6EA64E-CB37-6D52-A6F3-C2433284D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826AA0-4E51-2DA8-9E7B-EC7F3661E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49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92C25-BD7A-D077-A37C-E06ECE8A15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2EF96F-8084-AC67-9456-A08E954DE5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986BAD-6C82-11FD-F8AC-9ECC2D930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C15EC-44CD-FAE9-B87E-55FAFF6E5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0CE136-9B27-F644-D51A-D45BE7BC8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635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C9327-9780-9805-57D3-45DD2362A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6F264F-CEEC-79DD-8B35-99584E6531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640FB9-46FA-F473-A004-E672263A58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1860AC-0356-23B8-8278-B93C8D985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D0B0E6-D15A-A64A-6B8A-25B99EC76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7DB520-30A7-D7B4-1351-6CECE6D9A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500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7E80A5-622C-BA0D-FD87-753F29F40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F0BB7C-DFCD-65EB-7B15-A2865149BD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894A1A-34A9-B8A1-529F-7263CED05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286F4A-6950-471D-E163-03DE650185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6BD15B-B3EC-2676-ACE0-A65BF0091C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EB181B-172C-29B5-BCA5-504E5D27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9D21CC-77E5-0905-58E9-EC796BE4B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4691AFB-FC8C-2F48-47DC-396D8919E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09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5055A-5223-76A0-D2A4-E362D5A0C4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0E0F17-2055-6518-5642-500EABF17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A48021-3BC8-1F80-EA89-7C09D470F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80109D-0108-665A-D272-5618422C2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379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C4AECE-28D7-0CA6-783A-08C013056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C4C42E-02B9-494E-3B2D-2DD963AB6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969AD8-780C-C3A8-BEBA-7F8DCC484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912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B63226-30D8-92AD-349B-3A267899AD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E09461-A3DE-8737-1380-FE762D3A6A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4B9C03-FBDF-551B-75C3-852838B33E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DF8186-7524-7BF5-4A08-A71F65D7F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5DACFC-2613-50DD-64B0-B6E391136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21CEB5-BB93-C41B-E839-31C3CBE0D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20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C56282-C476-6D9D-6F46-8DFD8334F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4268BD-D359-FDFA-7661-E5B9899DC3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E1DCF1-3299-B9BA-D8AF-867BB0747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A9864D-7097-11F2-F05C-2F86EFD8C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C5BE74-4B34-2D7B-3C28-D33051E44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02118C-67FF-738F-965C-F65AE0E60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337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F1FFA-BA62-36E4-F251-B4FF69467F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C146B1-9D3E-1A84-7F61-7751025005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FCAD10-62A3-A80C-BEC4-46ED2C4D22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BE2DDEB-0705-4DBA-8B92-5E93474441F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AB3FD3-3DD0-00B1-32D1-AD2C92FC33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66C370-4633-BA4D-1AAA-10ADFB6B07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B9D295E-9C44-471E-BCB5-158BC9452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329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DC0FB7-DF89-AF21-1C47-A2D92423F71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5F7D55A-3CCE-4D98-C60F-39B322F5970E}"/>
              </a:ext>
            </a:extLst>
          </p:cNvPr>
          <p:cNvSpPr txBox="1"/>
          <p:nvPr/>
        </p:nvSpPr>
        <p:spPr>
          <a:xfrm>
            <a:off x="516106" y="3102029"/>
            <a:ext cx="519126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7350" marR="0" algn="l">
              <a:spcBef>
                <a:spcPts val="1200"/>
              </a:spcBef>
              <a:spcAft>
                <a:spcPts val="1200"/>
              </a:spcAft>
              <a:buNone/>
            </a:pPr>
            <a:r>
              <a:rPr lang="en-US" sz="1500" b="1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Supplemental Figure S1</a:t>
            </a:r>
            <a:r>
              <a:rPr lang="en-US" sz="15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. Representative </a:t>
            </a:r>
            <a:r>
              <a:rPr lang="en-US" sz="15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EdU</a:t>
            </a:r>
            <a:r>
              <a:rPr lang="en-US" sz="15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images corresponding to data represented in Figure 3 showing no effect of </a:t>
            </a:r>
            <a:r>
              <a:rPr lang="en-US" sz="15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MMP13</a:t>
            </a:r>
            <a:r>
              <a:rPr lang="en-US" sz="15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or </a:t>
            </a:r>
            <a:r>
              <a:rPr lang="en-US" sz="15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MMP13</a:t>
            </a:r>
            <a:r>
              <a:rPr lang="en-US" sz="15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inhibition on cellular proliferation. 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2B3CAF6E-5149-CB81-C782-8B57E24FF6A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4633" y="393970"/>
            <a:ext cx="4546925" cy="60700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A computer screen shot of a computer&#10;&#10;AI-generated content may be incorrect.">
            <a:extLst>
              <a:ext uri="{FF2B5EF4-FFF2-40B4-BE49-F238E27FC236}">
                <a16:creationId xmlns:a16="http://schemas.microsoft.com/office/drawing/2014/main" id="{38102684-340F-F0FB-F0F3-85A48632822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50281" t="84163" r="45923" b="13190"/>
          <a:stretch>
            <a:fillRect/>
          </a:stretch>
        </p:blipFill>
        <p:spPr bwMode="auto">
          <a:xfrm>
            <a:off x="8364044" y="6002116"/>
            <a:ext cx="331483" cy="13473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4" descr="A computer screen shot of a computer&#10;&#10;AI-generated content may be incorrect.">
            <a:extLst>
              <a:ext uri="{FF2B5EF4-FFF2-40B4-BE49-F238E27FC236}">
                <a16:creationId xmlns:a16="http://schemas.microsoft.com/office/drawing/2014/main" id="{672F4E25-30C6-A283-760B-6C3649D5183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50281" t="84163" r="45923" b="13190"/>
          <a:stretch>
            <a:fillRect/>
          </a:stretch>
        </p:blipFill>
        <p:spPr bwMode="auto">
          <a:xfrm>
            <a:off x="8364044" y="3976925"/>
            <a:ext cx="331483" cy="13473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 descr="A computer screen shot of a computer&#10;&#10;AI-generated content may be incorrect.">
            <a:extLst>
              <a:ext uri="{FF2B5EF4-FFF2-40B4-BE49-F238E27FC236}">
                <a16:creationId xmlns:a16="http://schemas.microsoft.com/office/drawing/2014/main" id="{1FB44413-4715-8065-BA70-FC3ECE1B0A9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50281" t="84163" r="45923" b="13190"/>
          <a:stretch>
            <a:fillRect/>
          </a:stretch>
        </p:blipFill>
        <p:spPr bwMode="auto">
          <a:xfrm>
            <a:off x="8364044" y="1884173"/>
            <a:ext cx="331483" cy="13473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7" descr="A computer screen shot of a computer&#10;&#10;AI-generated content may be incorrect.">
            <a:extLst>
              <a:ext uri="{FF2B5EF4-FFF2-40B4-BE49-F238E27FC236}">
                <a16:creationId xmlns:a16="http://schemas.microsoft.com/office/drawing/2014/main" id="{1169A954-7A0B-BFDF-525C-A6BDAFB3853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50281" t="84163" r="45923" b="13190"/>
          <a:stretch>
            <a:fillRect/>
          </a:stretch>
        </p:blipFill>
        <p:spPr bwMode="auto">
          <a:xfrm>
            <a:off x="10659781" y="6002116"/>
            <a:ext cx="331483" cy="13473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" descr="A computer screen shot of a computer&#10;&#10;AI-generated content may be incorrect.">
            <a:extLst>
              <a:ext uri="{FF2B5EF4-FFF2-40B4-BE49-F238E27FC236}">
                <a16:creationId xmlns:a16="http://schemas.microsoft.com/office/drawing/2014/main" id="{E4E2124D-F972-950D-0C57-BF96503F7C0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50281" t="84163" r="45923" b="13190"/>
          <a:stretch>
            <a:fillRect/>
          </a:stretch>
        </p:blipFill>
        <p:spPr bwMode="auto">
          <a:xfrm>
            <a:off x="10659781" y="3976925"/>
            <a:ext cx="331483" cy="13473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Picture 9" descr="A computer screen shot of a computer&#10;&#10;AI-generated content may be incorrect.">
            <a:extLst>
              <a:ext uri="{FF2B5EF4-FFF2-40B4-BE49-F238E27FC236}">
                <a16:creationId xmlns:a16="http://schemas.microsoft.com/office/drawing/2014/main" id="{76136878-9D62-EB8E-08BE-72977792D0B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50281" t="84163" r="45923" b="13190"/>
          <a:stretch>
            <a:fillRect/>
          </a:stretch>
        </p:blipFill>
        <p:spPr bwMode="auto">
          <a:xfrm>
            <a:off x="10659781" y="1884173"/>
            <a:ext cx="331483" cy="13473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9645259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6567B7-87DD-9C50-03BB-BB01E56BCE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64401FA-AA9E-58B4-4B6B-6268846502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3833" y="855949"/>
            <a:ext cx="4617903" cy="37314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E2DD148-9A18-473D-BCEA-9EC6DE4AA0B4}"/>
              </a:ext>
            </a:extLst>
          </p:cNvPr>
          <p:cNvSpPr txBox="1"/>
          <p:nvPr/>
        </p:nvSpPr>
        <p:spPr>
          <a:xfrm>
            <a:off x="-160257" y="4805573"/>
            <a:ext cx="10887959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7350" marR="0" algn="l">
              <a:spcBef>
                <a:spcPts val="1200"/>
              </a:spcBef>
              <a:spcAft>
                <a:spcPts val="1200"/>
              </a:spcAft>
              <a:buNone/>
            </a:pPr>
            <a:r>
              <a:rPr lang="en-US" sz="1500" b="1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Supplemental Figure S2</a:t>
            </a:r>
            <a:r>
              <a:rPr lang="en-US" sz="15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. Difference in </a:t>
            </a:r>
            <a:r>
              <a:rPr lang="en-US" sz="15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MMP</a:t>
            </a:r>
            <a:r>
              <a:rPr lang="en-US" sz="15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activity with or without </a:t>
            </a:r>
            <a:r>
              <a:rPr lang="en-US" sz="15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AMPA</a:t>
            </a:r>
            <a:r>
              <a:rPr lang="en-US" sz="15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treatment of culture supernatants collected at 0 hour, 12 hour, 24 hour, and 48 hour timepoints prior to performing the FRET assay (n=1).  </a:t>
            </a:r>
          </a:p>
        </p:txBody>
      </p:sp>
    </p:spTree>
    <p:extLst>
      <p:ext uri="{BB962C8B-B14F-4D97-AF65-F5344CB8AC3E}">
        <p14:creationId xmlns:p14="http://schemas.microsoft.com/office/powerpoint/2010/main" val="3316498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1</TotalTime>
  <Words>68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yva, Kathryn</dc:creator>
  <cp:lastModifiedBy>MDPI</cp:lastModifiedBy>
  <cp:revision>10</cp:revision>
  <dcterms:created xsi:type="dcterms:W3CDTF">2025-10-13T18:22:32Z</dcterms:created>
  <dcterms:modified xsi:type="dcterms:W3CDTF">2025-11-19T10:39:28Z</dcterms:modified>
</cp:coreProperties>
</file>